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837A5AE-79DF-B545-8346-6F31750239B1}" v="2" dt="2024-09-15T19:05:26.1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2"/>
    <p:restoredTop sz="94651"/>
  </p:normalViewPr>
  <p:slideViewPr>
    <p:cSldViewPr snapToGrid="0" showGuides="1">
      <p:cViewPr>
        <p:scale>
          <a:sx n="150" d="100"/>
          <a:sy n="150" d="100"/>
        </p:scale>
        <p:origin x="1608" y="14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0001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926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7630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3116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6540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425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6306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4603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1606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1944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9973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8BFEEE-CBFF-324E-8662-69A19F88F62D}" type="datetimeFigureOut">
              <a:rPr lang="en-GB" smtClean="0"/>
              <a:t>1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17AB40-8C8F-DC4E-B905-547F1459C1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138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6DBC0A6-641B-A016-6EAB-D3C86375EF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435" y="3747652"/>
            <a:ext cx="6350272" cy="337358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CD5D3F5-1FF7-92B7-D42D-BD7EC231C1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74071"/>
            <a:ext cx="6399882" cy="337358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28B60E3-DC9F-AB0F-4820-AA773CFA6A4B}"/>
              </a:ext>
            </a:extLst>
          </p:cNvPr>
          <p:cNvSpPr txBox="1"/>
          <p:nvPr/>
        </p:nvSpPr>
        <p:spPr>
          <a:xfrm>
            <a:off x="457200" y="7121233"/>
            <a:ext cx="5942682" cy="33445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upplementary Figure 1: Basal respiration and glycolysis of bovine MØ to stimulation with 2-DG, LPS and FSL-1 stimulation</a:t>
            </a:r>
            <a:endParaRPr lang="en-DE" sz="1200" dirty="0">
              <a:effectLst/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epresentative plot of OCR and ECAR of bovine MØ (Bo) upon stimulation with 1 mM 2-DG (Sigma-Aldrich, UK), 1</a:t>
            </a:r>
            <a:r>
              <a:rPr lang="en-GB" sz="1200" dirty="0">
                <a:effectLst/>
                <a:latin typeface="Arial" panose="020B0604020202020204" pitchFamily="34" charset="0"/>
                <a:ea typeface="Symbol" pitchFamily="2" charset="2"/>
                <a:cs typeface="Arial" panose="020B0604020202020204" pitchFamily="34" charset="0"/>
              </a:rPr>
              <a:t>m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g ml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LPS (</a:t>
            </a:r>
            <a:r>
              <a:rPr lang="en-GB" sz="12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Invivogen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USA)</a:t>
            </a:r>
            <a:r>
              <a:rPr lang="en-DE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100 ng ml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1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SL-1 (</a:t>
            </a:r>
            <a:r>
              <a:rPr lang="en-GB" sz="12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Invivogen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USA) for 24 h subjected to a Cell Mito Stress test (Agilent Technologies, USA) and measured with the Seahorse </a:t>
            </a:r>
            <a:r>
              <a:rPr lang="en-GB" sz="12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XFe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extracellular flux analyser (Agilent Technologies, USA) over 75 min. Following measurement of basal respiration, OCR and ECAR are recorded after injection of 1 </a:t>
            </a:r>
            <a:r>
              <a:rPr lang="en-GB" sz="1200" dirty="0">
                <a:effectLst/>
                <a:latin typeface="Arial" panose="020B0604020202020204" pitchFamily="34" charset="0"/>
                <a:ea typeface="Symbol" pitchFamily="2" charset="2"/>
                <a:cs typeface="Arial" panose="020B0604020202020204" pitchFamily="34" charset="0"/>
              </a:rPr>
              <a:t>m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M Oligomycin, followed by 2.0 </a:t>
            </a:r>
            <a:r>
              <a:rPr lang="en-GB" sz="1200" dirty="0">
                <a:effectLst/>
                <a:latin typeface="Arial" panose="020B0604020202020204" pitchFamily="34" charset="0"/>
                <a:ea typeface="Symbol" pitchFamily="2" charset="2"/>
                <a:cs typeface="Arial" panose="020B0604020202020204" pitchFamily="34" charset="0"/>
              </a:rPr>
              <a:t>m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M FCCP injection and 0.5 </a:t>
            </a:r>
            <a:r>
              <a:rPr lang="en-GB" sz="1200" dirty="0">
                <a:effectLst/>
                <a:latin typeface="Arial" panose="020B0604020202020204" pitchFamily="34" charset="0"/>
                <a:ea typeface="Symbol" pitchFamily="2" charset="2"/>
                <a:cs typeface="Arial" panose="020B0604020202020204" pitchFamily="34" charset="0"/>
              </a:rPr>
              <a:t>m</a:t>
            </a:r>
            <a:r>
              <a:rPr lang="en-GB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M of antimycin A and rotenone injection (injection time points are indicated by arrows). </a:t>
            </a:r>
            <a:endParaRPr lang="en-DE" sz="1200" dirty="0">
              <a:effectLst/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34DFB07C-A627-7192-5752-4226F8180FBC}"/>
              </a:ext>
            </a:extLst>
          </p:cNvPr>
          <p:cNvCxnSpPr/>
          <p:nvPr/>
        </p:nvCxnSpPr>
        <p:spPr>
          <a:xfrm>
            <a:off x="1517736" y="1187641"/>
            <a:ext cx="0" cy="6764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47214E3C-15DE-3F82-5D6D-B4D3FABC67DE}"/>
              </a:ext>
            </a:extLst>
          </p:cNvPr>
          <p:cNvCxnSpPr>
            <a:cxnSpLocks/>
          </p:cNvCxnSpPr>
          <p:nvPr/>
        </p:nvCxnSpPr>
        <p:spPr>
          <a:xfrm>
            <a:off x="2320214" y="1187641"/>
            <a:ext cx="0" cy="10944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CF4C2DB-BCD4-723C-AF01-E2C25178F332}"/>
              </a:ext>
            </a:extLst>
          </p:cNvPr>
          <p:cNvCxnSpPr>
            <a:cxnSpLocks/>
          </p:cNvCxnSpPr>
          <p:nvPr/>
        </p:nvCxnSpPr>
        <p:spPr>
          <a:xfrm>
            <a:off x="3199941" y="635680"/>
            <a:ext cx="0" cy="2646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AA3CF78-A4F8-B647-FF7B-EBA21BCFB571}"/>
              </a:ext>
            </a:extLst>
          </p:cNvPr>
          <p:cNvSpPr txBox="1"/>
          <p:nvPr/>
        </p:nvSpPr>
        <p:spPr>
          <a:xfrm>
            <a:off x="1084545" y="769564"/>
            <a:ext cx="9269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igomyc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B8A8C89-E834-CE1D-86FD-B98FEEB44E0C}"/>
              </a:ext>
            </a:extLst>
          </p:cNvPr>
          <p:cNvSpPr txBox="1"/>
          <p:nvPr/>
        </p:nvSpPr>
        <p:spPr>
          <a:xfrm>
            <a:off x="1995581" y="832848"/>
            <a:ext cx="6492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CP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4DDCD6F-BC1B-B7EC-16DF-5D5D41483A4C}"/>
              </a:ext>
            </a:extLst>
          </p:cNvPr>
          <p:cNvSpPr txBox="1"/>
          <p:nvPr/>
        </p:nvSpPr>
        <p:spPr>
          <a:xfrm>
            <a:off x="2736478" y="187704"/>
            <a:ext cx="92692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mycin &amp; Rotenone   </a:t>
            </a:r>
          </a:p>
        </p:txBody>
      </p:sp>
    </p:spTree>
    <p:extLst>
      <p:ext uri="{BB962C8B-B14F-4D97-AF65-F5344CB8AC3E}">
        <p14:creationId xmlns:p14="http://schemas.microsoft.com/office/powerpoint/2010/main" val="1261232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143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erling, Dirk</dc:creator>
  <cp:lastModifiedBy>Werling, Dirk</cp:lastModifiedBy>
  <cp:revision>1</cp:revision>
  <dcterms:created xsi:type="dcterms:W3CDTF">2024-09-15T18:52:55Z</dcterms:created>
  <dcterms:modified xsi:type="dcterms:W3CDTF">2024-09-15T19:06:06Z</dcterms:modified>
</cp:coreProperties>
</file>